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  <p:sldMasterId id="2147483708" r:id="rId2"/>
  </p:sldMasterIdLst>
  <p:notesMasterIdLst>
    <p:notesMasterId r:id="rId4"/>
  </p:notesMasterIdLst>
  <p:sldIdLst>
    <p:sldId id="304" r:id="rId3"/>
  </p:sldIdLst>
  <p:sldSz cx="9144000" cy="6858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" userDrawn="1">
          <p15:clr>
            <a:srgbClr val="A4A3A4"/>
          </p15:clr>
        </p15:guide>
        <p15:guide id="2" pos="5534" userDrawn="1">
          <p15:clr>
            <a:srgbClr val="A4A3A4"/>
          </p15:clr>
        </p15:guide>
        <p15:guide id="3" orient="horz" pos="3566" userDrawn="1">
          <p15:clr>
            <a:srgbClr val="A4A3A4"/>
          </p15:clr>
        </p15:guide>
        <p15:guide id="4" orient="horz" pos="1389" userDrawn="1">
          <p15:clr>
            <a:srgbClr val="A4A3A4"/>
          </p15:clr>
        </p15:guide>
        <p15:guide id="5" pos="2744" userDrawn="1">
          <p15:clr>
            <a:srgbClr val="A4A3A4"/>
          </p15:clr>
        </p15:guide>
        <p15:guide id="6" orient="horz" pos="2750" userDrawn="1">
          <p15:clr>
            <a:srgbClr val="A4A3A4"/>
          </p15:clr>
        </p15:guide>
        <p15:guide id="7" pos="5307" userDrawn="1">
          <p15:clr>
            <a:srgbClr val="A4A3A4"/>
          </p15:clr>
        </p15:guide>
        <p15:guide id="8" pos="1292" userDrawn="1">
          <p15:clr>
            <a:srgbClr val="A4A3A4"/>
          </p15:clr>
        </p15:guide>
        <p15:guide id="9" pos="4604" userDrawn="1">
          <p15:clr>
            <a:srgbClr val="A4A3A4"/>
          </p15:clr>
        </p15:guide>
        <p15:guide id="10" pos="333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arten van de Guchte" initials="MvdG" lastIdx="4" clrIdx="0">
    <p:extLst>
      <p:ext uri="{19B8F6BF-5375-455C-9EA6-DF929625EA0E}">
        <p15:presenceInfo xmlns:p15="http://schemas.microsoft.com/office/powerpoint/2012/main" userId="Maarten van de Gucht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  <a:srgbClr val="FF0000"/>
    <a:srgbClr val="FF7C80"/>
    <a:srgbClr val="00B050"/>
    <a:srgbClr val="FFFFFF"/>
    <a:srgbClr val="FF9B00"/>
    <a:srgbClr val="A6A6A6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86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1764" y="114"/>
      </p:cViewPr>
      <p:guideLst>
        <p:guide orient="horz" pos="323"/>
        <p:guide pos="5534"/>
        <p:guide orient="horz" pos="3566"/>
        <p:guide orient="horz" pos="1389"/>
        <p:guide pos="2744"/>
        <p:guide orient="horz" pos="2750"/>
        <p:guide pos="5307"/>
        <p:guide pos="1292"/>
        <p:guide pos="4604"/>
        <p:guide pos="33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3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50F2E697-80E6-43A4-94DA-33790D5D0D80}" type="datetimeFigureOut">
              <a:rPr lang="fr-FR" smtClean="0"/>
              <a:t>06/03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3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71CF340F-E5BB-49A5-A91A-0051F3291D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86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249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49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7495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786820"/>
            <a:ext cx="7772400" cy="1470025"/>
          </a:xfrm>
        </p:spPr>
        <p:txBody>
          <a:bodyPr/>
          <a:lstStyle>
            <a:lvl1pPr algn="ctr"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0" y="4950215"/>
            <a:ext cx="91440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4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dirty="0" smtClean="0"/>
              <a:t>Cliquez pour 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F8020-3201-416E-B4A9-078C42C8DF9D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2C3B1C-C00C-429F-8D7C-D88BDB4DE7FD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1673309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A3C9D1-5075-4A22-934D-04F07BF764D5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7207-2A82-41CB-8DE2-2D9DD495ACB8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1826333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/>
          <a:lstStyle>
            <a:lvl1pPr algn="ctr">
              <a:defRPr sz="4267" b="1" cap="all"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 algn="ctr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1pPr>
            <a:lvl2pPr marL="487686" indent="0">
              <a:buNone/>
              <a:defRPr sz="1956">
                <a:solidFill>
                  <a:schemeClr val="tx1">
                    <a:tint val="75000"/>
                  </a:schemeClr>
                </a:solidFill>
              </a:defRPr>
            </a:lvl2pPr>
            <a:lvl3pPr marL="975372" indent="0">
              <a:buNone/>
              <a:defRPr sz="1689">
                <a:solidFill>
                  <a:schemeClr val="tx1">
                    <a:tint val="75000"/>
                  </a:schemeClr>
                </a:solidFill>
              </a:defRPr>
            </a:lvl3pPr>
            <a:lvl4pPr marL="1463058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4pPr>
            <a:lvl5pPr marL="1950744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5pPr>
            <a:lvl6pPr marL="2438430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6pPr>
            <a:lvl7pPr marL="2926117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7pPr>
            <a:lvl8pPr marL="3413803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8pPr>
            <a:lvl9pPr marL="3901489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789F88-DDC5-41B1-BF69-A475DAFB9C9C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DCCADB-6DE0-4773-8675-A4391FC7D087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87802546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AD206-38DE-4B04-B46B-7FBE5A7BC9FE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35145-3EBC-483D-9860-1005D1429B65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26429109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1352" y="274639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975244"/>
            <a:ext cx="4040188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615003"/>
            <a:ext cx="4040188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8" y="1975244"/>
            <a:ext cx="4041775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8" y="2615003"/>
            <a:ext cx="4041775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31854F-951E-4FAB-B84B-3C2BA5047CAF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1E697-9B4B-4F21-97C0-3A9C2AC6E63E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41893752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2877" y="175685"/>
            <a:ext cx="7591425" cy="670940"/>
          </a:xfrm>
        </p:spPr>
        <p:txBody>
          <a:bodyPr/>
          <a:lstStyle/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2A2FA2-298D-4083-BBD2-1794C6D3D88B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2C9AD-1D0A-4345-9608-099F3330A7D9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8813010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ED2ADA-88B8-4003-9628-939467E7EA11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59917E-83F6-42A0-B5E8-A5558944F75B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808008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098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124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90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68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764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552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516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39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8425-0099-46C6-9530-24BC6ABCF70D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694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142523" y="176213"/>
            <a:ext cx="7591778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ET MODIFIEZ LE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00567" y="1600201"/>
            <a:ext cx="8504766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s styles du texte du masque</a:t>
            </a:r>
          </a:p>
          <a:p>
            <a:pPr lvl="1"/>
            <a:r>
              <a:rPr lang="fr-FR" altLang="fr-FR" smtClean="0"/>
              <a:t>Deuxième niveau</a:t>
            </a:r>
          </a:p>
          <a:p>
            <a:pPr lvl="2"/>
            <a:r>
              <a:rPr lang="fr-FR" altLang="fr-FR" smtClean="0"/>
              <a:t>Troisième niveau</a:t>
            </a:r>
          </a:p>
          <a:p>
            <a:pPr lvl="3"/>
            <a:r>
              <a:rPr lang="fr-FR" altLang="fr-FR" smtClean="0"/>
              <a:t>Quatrième niveau</a:t>
            </a:r>
          </a:p>
          <a:p>
            <a:pPr lvl="4"/>
            <a:r>
              <a:rPr lang="fr-FR" alt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6BC86E7-943C-4492-B617-50DB58347FDA}" type="datetimeFigureOut">
              <a:rPr lang="fr-FR" altLang="fr-FR"/>
              <a:pPr>
                <a:defRPr/>
              </a:pPr>
              <a:t>06/03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6713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ctr" defTabSz="487686" eaLnBrk="1" fontAlgn="auto" hangingPunct="1">
              <a:spcBef>
                <a:spcPts val="0"/>
              </a:spcBef>
              <a:spcAft>
                <a:spcPts val="0"/>
              </a:spcAft>
              <a:defRPr sz="1244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6E11EF32-C6FC-46EF-8F68-27A468F85D04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252932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</p:sldLayoutIdLst>
  <p:txStyles>
    <p:titleStyle>
      <a:lvl1pPr algn="l" defTabSz="486840" rtl="0" eaLnBrk="0" fontAlgn="base" hangingPunct="0">
        <a:spcBef>
          <a:spcPct val="0"/>
        </a:spcBef>
        <a:spcAft>
          <a:spcPct val="0"/>
        </a:spcAft>
        <a:defRPr sz="2578" b="1" kern="1200">
          <a:solidFill>
            <a:srgbClr val="7EB6CF"/>
          </a:solidFill>
          <a:latin typeface="Arial"/>
          <a:ea typeface="MS PGothic" pitchFamily="34" charset="-128"/>
          <a:cs typeface="Arial"/>
        </a:defRPr>
      </a:lvl1pPr>
      <a:lvl2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2pPr>
      <a:lvl3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3pPr>
      <a:lvl4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4pPr>
      <a:lvl5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5pPr>
      <a:lvl6pPr marL="487686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6pPr>
      <a:lvl7pPr marL="975372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7pPr>
      <a:lvl8pPr marL="1463058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8pPr>
      <a:lvl9pPr marL="1950744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9pPr>
    </p:titleStyle>
    <p:bodyStyle>
      <a:lvl1pPr marL="190503" indent="-266704" algn="l" defTabSz="486840" rtl="0" eaLnBrk="0" fontAlgn="base" hangingPunct="0">
        <a:spcBef>
          <a:spcPct val="20000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578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1pPr>
      <a:lvl2pPr marL="19050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2pPr>
      <a:lvl3pPr marL="382416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3pPr>
      <a:lvl4pPr marL="575741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4pPr>
      <a:lvl5pPr marL="76624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5pPr>
      <a:lvl6pPr marL="2682274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6pPr>
      <a:lvl7pPr marL="3169960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7pPr>
      <a:lvl8pPr marL="3657646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8pPr>
      <a:lvl9pPr marL="4145332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1pPr>
      <a:lvl2pPr marL="487686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2pPr>
      <a:lvl3pPr marL="975372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3pPr>
      <a:lvl4pPr marL="1463058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1950744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43843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2926117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413803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3901489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gi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7268832" y="6386393"/>
            <a:ext cx="1673856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lvl="0" algn="r">
              <a:defRPr/>
            </a:pP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</a:t>
            </a: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3" name="Groupe 2"/>
          <p:cNvGrpSpPr/>
          <p:nvPr/>
        </p:nvGrpSpPr>
        <p:grpSpPr>
          <a:xfrm>
            <a:off x="1637040" y="887377"/>
            <a:ext cx="6010423" cy="4848290"/>
            <a:chOff x="1637040" y="1203573"/>
            <a:chExt cx="6010423" cy="4848290"/>
          </a:xfrm>
        </p:grpSpPr>
        <p:graphicFrame>
          <p:nvGraphicFramePr>
            <p:cNvPr id="5" name="Obje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68785228"/>
                </p:ext>
              </p:extLst>
            </p:nvPr>
          </p:nvGraphicFramePr>
          <p:xfrm>
            <a:off x="1923819" y="1277839"/>
            <a:ext cx="5723644" cy="26797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744" name="Prism 7" r:id="rId3" imgW="8694757" imgH="4072262" progId="Prism7.Document">
                    <p:embed/>
                  </p:oleObj>
                </mc:Choice>
                <mc:Fallback>
                  <p:oleObj name="Prism 7" r:id="rId3" imgW="8694757" imgH="4072262" progId="Prism7.Document">
                    <p:embed/>
                    <p:pic>
                      <p:nvPicPr>
                        <p:cNvPr id="2" name="Objet 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923819" y="1277839"/>
                          <a:ext cx="5723644" cy="26797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" name="Groupe 5"/>
            <p:cNvGrpSpPr/>
            <p:nvPr/>
          </p:nvGrpSpPr>
          <p:grpSpPr>
            <a:xfrm>
              <a:off x="1740111" y="4078984"/>
              <a:ext cx="2628142" cy="1972879"/>
              <a:chOff x="4547005" y="3946890"/>
              <a:chExt cx="2463078" cy="1848969"/>
            </a:xfrm>
          </p:grpSpPr>
          <p:pic>
            <p:nvPicPr>
              <p:cNvPr id="20" name="Image 19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72000" y="4008644"/>
                <a:ext cx="2438083" cy="1741488"/>
              </a:xfrm>
              <a:prstGeom prst="rect">
                <a:avLst/>
              </a:prstGeom>
            </p:spPr>
          </p:pic>
          <p:sp>
            <p:nvSpPr>
              <p:cNvPr id="21" name="ZoneTexte 20"/>
              <p:cNvSpPr txBox="1"/>
              <p:nvPr/>
            </p:nvSpPr>
            <p:spPr>
              <a:xfrm rot="16200000">
                <a:off x="3730242" y="4763653"/>
                <a:ext cx="1848969" cy="215444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1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cteroides</a:t>
                </a:r>
                <a:r>
                  <a:rPr kumimoji="0" lang="fr-FR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kumimoji="0" lang="fr-FR" sz="800" b="0" i="1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revotella </a:t>
                </a:r>
                <a:r>
                  <a:rPr kumimoji="0" lang="fr-FR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(MiSeq)</a:t>
                </a: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4948177" y="5557454"/>
                <a:ext cx="1822738" cy="215444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1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cteroides</a:t>
                </a:r>
                <a:r>
                  <a:rPr kumimoji="0" lang="fr-FR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kumimoji="0" lang="fr-FR" sz="800" b="0" i="1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revotella</a:t>
                </a:r>
                <a:r>
                  <a:rPr kumimoji="0" lang="fr-FR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 (qPCR)</a:t>
                </a:r>
              </a:p>
            </p:txBody>
          </p:sp>
        </p:grpSp>
        <p:grpSp>
          <p:nvGrpSpPr>
            <p:cNvPr id="7" name="Groupe 6"/>
            <p:cNvGrpSpPr/>
            <p:nvPr/>
          </p:nvGrpSpPr>
          <p:grpSpPr>
            <a:xfrm>
              <a:off x="4718351" y="4100322"/>
              <a:ext cx="2637764" cy="1781009"/>
              <a:chOff x="1526528" y="5490317"/>
              <a:chExt cx="3041507" cy="1957313"/>
            </a:xfrm>
          </p:grpSpPr>
          <p:graphicFrame>
            <p:nvGraphicFramePr>
              <p:cNvPr id="18" name="Objet 1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47848801"/>
                  </p:ext>
                </p:extLst>
              </p:nvPr>
            </p:nvGraphicFramePr>
            <p:xfrm>
              <a:off x="1718377" y="5522778"/>
              <a:ext cx="2849658" cy="192485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745" name="Prism 7" r:id="rId6" imgW="7426359" imgH="5008616" progId="Prism7.Document">
                      <p:embed/>
                    </p:oleObj>
                  </mc:Choice>
                  <mc:Fallback>
                    <p:oleObj name="Prism 7" r:id="rId6" imgW="7426359" imgH="5008616" progId="Prism7.Document">
                      <p:embed/>
                      <p:pic>
                        <p:nvPicPr>
                          <p:cNvPr id="28" name="Objet 27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1718377" y="5522778"/>
                            <a:ext cx="2849658" cy="192485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9" name="ZoneTexte 18"/>
              <p:cNvSpPr txBox="1"/>
              <p:nvPr/>
            </p:nvSpPr>
            <p:spPr>
              <a:xfrm rot="16200000">
                <a:off x="701685" y="6315160"/>
                <a:ext cx="1865129" cy="215444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ody weight (g)</a:t>
                </a:r>
              </a:p>
            </p:txBody>
          </p:sp>
        </p:grpSp>
        <p:sp>
          <p:nvSpPr>
            <p:cNvPr id="8" name="ZoneTexte 7"/>
            <p:cNvSpPr txBox="1"/>
            <p:nvPr/>
          </p:nvSpPr>
          <p:spPr>
            <a:xfrm rot="16200000">
              <a:off x="816216" y="2227943"/>
              <a:ext cx="1871529" cy="229882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cteroides</a:t>
              </a: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  <a:r>
                <a:rPr kumimoji="0" lang="fr-FR" sz="800" b="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evotella</a:t>
              </a: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(qPCR)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290399" y="1328741"/>
              <a:ext cx="705451" cy="215444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% DSS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125387" y="1328741"/>
              <a:ext cx="764378" cy="215444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5% DSS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4032933" y="1328741"/>
              <a:ext cx="705451" cy="215444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5% DSS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908524" y="1335333"/>
              <a:ext cx="705451" cy="215444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% DSS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5771769" y="1331963"/>
              <a:ext cx="705451" cy="215444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% DSS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6643561" y="1329009"/>
              <a:ext cx="705451" cy="215444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% DSS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7259475" y="120357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147469" y="4130470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6927918" y="412507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90962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2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97</TotalTime>
  <Words>48</Words>
  <Application>Microsoft Office PowerPoint</Application>
  <PresentationFormat>Affichage à l'écran (4:3)</PresentationFormat>
  <Paragraphs>14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2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ＭＳ Ｐゴシック</vt:lpstr>
      <vt:lpstr>ＭＳ Ｐゴシック</vt:lpstr>
      <vt:lpstr>Arial</vt:lpstr>
      <vt:lpstr>Calibri</vt:lpstr>
      <vt:lpstr>12_Thème Office</vt:lpstr>
      <vt:lpstr>1_Thème Office</vt:lpstr>
      <vt:lpstr>Prism 7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arten van de Guchte</dc:creator>
  <cp:lastModifiedBy>Maarten Van-De-Guchte</cp:lastModifiedBy>
  <cp:revision>658</cp:revision>
  <cp:lastPrinted>2019-06-19T07:35:14Z</cp:lastPrinted>
  <dcterms:created xsi:type="dcterms:W3CDTF">2018-07-18T09:48:41Z</dcterms:created>
  <dcterms:modified xsi:type="dcterms:W3CDTF">2020-03-06T16:52:28Z</dcterms:modified>
</cp:coreProperties>
</file>